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15"/>
  </p:notesMasterIdLst>
  <p:sldIdLst>
    <p:sldId id="256" r:id="rId2"/>
    <p:sldId id="257" r:id="rId3"/>
    <p:sldId id="269" r:id="rId4"/>
    <p:sldId id="266" r:id="rId5"/>
    <p:sldId id="267" r:id="rId6"/>
    <p:sldId id="258" r:id="rId7"/>
    <p:sldId id="259" r:id="rId8"/>
    <p:sldId id="260" r:id="rId9"/>
    <p:sldId id="261" r:id="rId10"/>
    <p:sldId id="262" r:id="rId11"/>
    <p:sldId id="263" r:id="rId12"/>
    <p:sldId id="264" r:id="rId13"/>
    <p:sldId id="268" r:id="rId1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1429"/>
    <p:restoredTop sz="94611"/>
  </p:normalViewPr>
  <p:slideViewPr>
    <p:cSldViewPr snapToGrid="0">
      <p:cViewPr varScale="1">
        <p:scale>
          <a:sx n="109" d="100"/>
          <a:sy n="109" d="100"/>
        </p:scale>
        <p:origin x="920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notesMaster" Target="notesMasters/notesMaster1.xml"/><Relationship Id="rId10" Type="http://schemas.openxmlformats.org/officeDocument/2006/relationships/slide" Target="slides/slide9.xml"/><Relationship Id="rId19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5BE7EDD-9CE3-7B44-A77F-DEB9D63E3ABE}" type="datetimeFigureOut">
              <a:rPr lang="en-US" smtClean="0"/>
              <a:t>12/8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92D21CC-A726-8941-B5EA-66D36380D0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87859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Change to all specific numbers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92D21CC-A726-8941-B5EA-66D36380D018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609353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Change from 0 CE to 1 CE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92D21CC-A726-8941-B5EA-66D36380D018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210202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9F4DA8F-DA8E-9830-775E-C1F1CA74883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69642E9-A056-6B03-EFE1-BBE7AF762A4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1FCD977-3F88-85A5-D0CC-B29EB3490B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90E86B-4E64-984E-9AFD-BDDFB65DF84E}" type="datetimeFigureOut">
              <a:rPr lang="en-US" smtClean="0"/>
              <a:t>12/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AF8506A-D03E-9D89-655C-3038ACDE5E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B0CE7DE-4D59-01E3-6AFA-97EA2A025C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DDAF7C-999A-8F4C-A23D-1B439817AC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09200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F93CB7E-3961-A151-FCD3-1DB99EF2B6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D4D7B05-E22C-E0F6-6415-60EEFCA2889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09D61E2-7DD1-A135-BD98-D0A8AC16EE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90E86B-4E64-984E-9AFD-BDDFB65DF84E}" type="datetimeFigureOut">
              <a:rPr lang="en-US" smtClean="0"/>
              <a:t>12/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7FA60F1-AF63-39E5-6AFB-3394E9F885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F4F5539-363E-AF4E-FEA6-17AF75987F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DDAF7C-999A-8F4C-A23D-1B439817AC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02654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A8151AB-B129-49A9-6B5B-B63B70C97B5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247BF07-299B-CFF4-4BE8-B0609966CDB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13C261E-D452-5F27-C393-8B1506CA60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90E86B-4E64-984E-9AFD-BDDFB65DF84E}" type="datetimeFigureOut">
              <a:rPr lang="en-US" smtClean="0"/>
              <a:t>12/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BA96856-9356-5210-06A8-22A1988D83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C250FC8-9295-9FAC-0299-B4DBC51909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DDAF7C-999A-8F4C-A23D-1B439817AC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2277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60751D-EE22-5F53-FA44-F743C1F0E8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1C039D5-A1FD-A30D-4C47-4ED2069EDBE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ED28527-2661-2015-D76D-1921EC1AAA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90E86B-4E64-984E-9AFD-BDDFB65DF84E}" type="datetimeFigureOut">
              <a:rPr lang="en-US" smtClean="0"/>
              <a:t>12/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8DE924F-ED08-846F-96C3-48FDA0A667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C140261-B686-91C2-4F69-288CEB209E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DDAF7C-999A-8F4C-A23D-1B439817AC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3890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71584F-51F6-AA5D-053C-71E41DDB87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41E3396-0634-94B3-7CC4-438A48AEC50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37E825D-DE7D-DE17-EB2B-8ACCD4497E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90E86B-4E64-984E-9AFD-BDDFB65DF84E}" type="datetimeFigureOut">
              <a:rPr lang="en-US" smtClean="0"/>
              <a:t>12/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1D5EEC9-C06C-50B7-5270-90C870937E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1C2E90B-8698-C7C7-DFB4-2A1DE1A5F1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DDAF7C-999A-8F4C-A23D-1B439817AC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9417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456A26C-0E5E-2E38-93F3-B2735465865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D5D032C-E547-45E7-33CE-445B437E466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26E06EC-C013-0755-37AE-DEDC5EE8936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C512EE7-36A9-5D68-4A25-BFD65C9754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90E86B-4E64-984E-9AFD-BDDFB65DF84E}" type="datetimeFigureOut">
              <a:rPr lang="en-US" smtClean="0"/>
              <a:t>12/8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796C47C-0709-B780-6D42-A4FBCDA070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9F5A1F7-FB9C-351C-3F10-30EC27E86C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DDAF7C-999A-8F4C-A23D-1B439817AC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68149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F0511A-9BC4-CDAB-C009-94EB6E4431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89B3B2E-AD1D-6902-9970-B92BE064896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609CFCB-9F39-0737-B68A-55AC9CCD838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D8BB4DD-F63B-D50F-F085-69AE24C5991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B03471E-9398-04AF-297C-BD8A7821A19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EC70DAA-EB03-E367-C218-576AA1CBB2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90E86B-4E64-984E-9AFD-BDDFB65DF84E}" type="datetimeFigureOut">
              <a:rPr lang="en-US" smtClean="0"/>
              <a:t>12/8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F5C3EB5-F32A-16C9-6824-D0A9D2BF05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2DEF566-FF60-6946-0E91-9856211283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DDAF7C-999A-8F4C-A23D-1B439817AC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67785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4788B8-E6FF-4601-B132-34AC64E2D34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B28ACAC-0C01-7FE2-67A0-2D70F8CE4D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90E86B-4E64-984E-9AFD-BDDFB65DF84E}" type="datetimeFigureOut">
              <a:rPr lang="en-US" smtClean="0"/>
              <a:t>12/8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AC4785B-055A-2357-722A-598E76D97F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97D0EEA-4B1C-3747-92BE-67DA73766C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DDAF7C-999A-8F4C-A23D-1B439817AC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66451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0BEF316-D040-112E-BEE4-EB52065B64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90E86B-4E64-984E-9AFD-BDDFB65DF84E}" type="datetimeFigureOut">
              <a:rPr lang="en-US" smtClean="0"/>
              <a:t>12/8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285F7FA-5A74-CF69-CEB7-B01C9407A1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B45EBE6-9705-3F3C-510A-D3D837627A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DDAF7C-999A-8F4C-A23D-1B439817AC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29254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1B55E97-B960-7DB3-7EA4-A2000A105E8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9413522-692B-A533-0F51-9C0C8B451F1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EE752BC-AE2E-B34B-2E90-B6660E674AA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4A21CC1-B306-926E-19B8-17FD580AD2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90E86B-4E64-984E-9AFD-BDDFB65DF84E}" type="datetimeFigureOut">
              <a:rPr lang="en-US" smtClean="0"/>
              <a:t>12/8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7E7C89E-8247-40C2-E082-F6BC25C67A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2DAF842-82C9-E334-907A-2ACF13D2F4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DDAF7C-999A-8F4C-A23D-1B439817AC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02610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C53A1C0-40FA-9B61-2939-EDE6697BDA4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C20914F-43A1-E04D-76B4-929CB4B201D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0850661-282A-9633-FE51-C98134B8161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5E243F3-D034-5BEA-0863-EF1678B991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90E86B-4E64-984E-9AFD-BDDFB65DF84E}" type="datetimeFigureOut">
              <a:rPr lang="en-US" smtClean="0"/>
              <a:t>12/8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05F929E-1A8F-362A-80C7-2F4E635CA3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4C3D7ED-8208-BF34-FD6E-DFEDC6B615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DDAF7C-999A-8F4C-A23D-1B439817AC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77003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6474411-286B-BD76-ED50-B3B2B422D8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FC66397-E14F-CF84-4DEA-4ABEBFF6EC1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D5526CE-5DB1-2F6B-F2F3-DB35A056AFA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390E86B-4E64-984E-9AFD-BDDFB65DF84E}" type="datetimeFigureOut">
              <a:rPr lang="en-US" smtClean="0"/>
              <a:t>12/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A0C3579-12AF-20EE-EF3C-1B594CE97F7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465FE94-8995-4EBF-FF11-5030FC0D966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ADDAF7C-999A-8F4C-A23D-1B439817AC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22847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1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1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3361FC59-7C43-F758-85F2-A9E6F1FE1C53}"/>
              </a:ext>
            </a:extLst>
          </p:cNvPr>
          <p:cNvSpPr txBox="1"/>
          <p:nvPr/>
        </p:nvSpPr>
        <p:spPr>
          <a:xfrm>
            <a:off x="130629" y="118753"/>
            <a:ext cx="42033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1: Top-level branching for CB-01 </a:t>
            </a:r>
          </a:p>
        </p:txBody>
      </p:sp>
      <p:pic>
        <p:nvPicPr>
          <p:cNvPr id="7" name="Picture 6" descr="A diagram of a company&#10;&#10;Description automatically generated">
            <a:extLst>
              <a:ext uri="{FF2B5EF4-FFF2-40B4-BE49-F238E27FC236}">
                <a16:creationId xmlns:a16="http://schemas.microsoft.com/office/drawing/2014/main" id="{C4EFC347-6873-977E-9648-F09147402B0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67070" y="1717259"/>
            <a:ext cx="9503898" cy="297400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12472117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7B11941-4FDD-D029-2E66-0C2401A913B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65BE3AA7-0E4A-BF5B-DF51-53B59B7F3D65}"/>
              </a:ext>
            </a:extLst>
          </p:cNvPr>
          <p:cNvSpPr txBox="1"/>
          <p:nvPr/>
        </p:nvSpPr>
        <p:spPr>
          <a:xfrm>
            <a:off x="130629" y="118753"/>
            <a:ext cx="64905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9: Top-level branching for CB-06, with nearest outgroup </a:t>
            </a:r>
          </a:p>
        </p:txBody>
      </p:sp>
      <p:pic>
        <p:nvPicPr>
          <p:cNvPr id="5" name="Picture 4" descr="A diagram of a number&#10;&#10;Description automatically generated">
            <a:extLst>
              <a:ext uri="{FF2B5EF4-FFF2-40B4-BE49-F238E27FC236}">
                <a16:creationId xmlns:a16="http://schemas.microsoft.com/office/drawing/2014/main" id="{FDD58CAA-126E-1750-49F3-1B1A330E2BD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22349" y="1409700"/>
            <a:ext cx="9876762" cy="393092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126564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BA78676-4EA4-D784-81B4-9949DDB994B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35A35A51-C387-FFE3-4F6E-A8B444DE860A}"/>
              </a:ext>
            </a:extLst>
          </p:cNvPr>
          <p:cNvSpPr txBox="1"/>
          <p:nvPr/>
        </p:nvSpPr>
        <p:spPr>
          <a:xfrm>
            <a:off x="130629" y="118753"/>
            <a:ext cx="66059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10: Top-level branching for CB-07, with nearest outgroup </a:t>
            </a:r>
          </a:p>
        </p:txBody>
      </p:sp>
      <p:pic>
        <p:nvPicPr>
          <p:cNvPr id="5" name="Picture 4" descr="A diagram of a number system&#10;&#10;Description automatically generated">
            <a:extLst>
              <a:ext uri="{FF2B5EF4-FFF2-40B4-BE49-F238E27FC236}">
                <a16:creationId xmlns:a16="http://schemas.microsoft.com/office/drawing/2014/main" id="{16C0C268-2B62-C20B-F7D5-9A3FCEFC83D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54050" y="1160946"/>
            <a:ext cx="10597046" cy="416565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00128017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A943442-0DAD-BBDA-2E2B-64BE1480990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91F08CC8-EC24-4C2A-B6F4-778D8F88A848}"/>
              </a:ext>
            </a:extLst>
          </p:cNvPr>
          <p:cNvSpPr txBox="1"/>
          <p:nvPr/>
        </p:nvSpPr>
        <p:spPr>
          <a:xfrm>
            <a:off x="130629" y="118753"/>
            <a:ext cx="65932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11: Top-level branching for CB-08, with nearest outgroup </a:t>
            </a:r>
          </a:p>
        </p:txBody>
      </p:sp>
      <p:pic>
        <p:nvPicPr>
          <p:cNvPr id="5" name="Picture 4" descr="A diagram of a number&#10;&#10;Description automatically generated">
            <a:extLst>
              <a:ext uri="{FF2B5EF4-FFF2-40B4-BE49-F238E27FC236}">
                <a16:creationId xmlns:a16="http://schemas.microsoft.com/office/drawing/2014/main" id="{3414EDE2-0B74-1490-01FC-131932D4B8A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23950" y="1466849"/>
            <a:ext cx="9544050" cy="37664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9298153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F24E1323-1EC6-6447-7BC0-89CBB70EE5A8}"/>
              </a:ext>
            </a:extLst>
          </p:cNvPr>
          <p:cNvSpPr txBox="1"/>
          <p:nvPr/>
        </p:nvSpPr>
        <p:spPr>
          <a:xfrm>
            <a:off x="130629" y="118753"/>
            <a:ext cx="46689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12: J-ZS222, the CB-01-defining block</a:t>
            </a:r>
          </a:p>
        </p:txBody>
      </p:sp>
      <p:pic>
        <p:nvPicPr>
          <p:cNvPr id="5" name="Picture 4" descr="A screenshot of a computer code&#10;&#10;Description automatically generated">
            <a:extLst>
              <a:ext uri="{FF2B5EF4-FFF2-40B4-BE49-F238E27FC236}">
                <a16:creationId xmlns:a16="http://schemas.microsoft.com/office/drawing/2014/main" id="{713DEE6A-12FA-0761-6884-FD6A5DFE5CE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98899" y="546100"/>
            <a:ext cx="4603347" cy="604023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4563441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CB665A49-791A-25A1-149F-628083D8AE75}"/>
              </a:ext>
            </a:extLst>
          </p:cNvPr>
          <p:cNvSpPr txBox="1"/>
          <p:nvPr/>
        </p:nvSpPr>
        <p:spPr>
          <a:xfrm>
            <a:off x="163285" y="124093"/>
            <a:ext cx="7491883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2a: Top-level branching for J-Z18271, CB-01’s main expansion node </a:t>
            </a:r>
          </a:p>
        </p:txBody>
      </p:sp>
      <p:pic>
        <p:nvPicPr>
          <p:cNvPr id="6" name="Picture 5" descr="A diagram of a number&#10;&#10;Description automatically generated">
            <a:extLst>
              <a:ext uri="{FF2B5EF4-FFF2-40B4-BE49-F238E27FC236}">
                <a16:creationId xmlns:a16="http://schemas.microsoft.com/office/drawing/2014/main" id="{7BD75F1D-1796-F744-03B7-A0BA39D10EF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62407" y="695186"/>
            <a:ext cx="5734602" cy="568847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8974599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74FA477-3799-6EC9-4629-DDC814CD0EA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ounded Rectangle 3">
            <a:extLst>
              <a:ext uri="{FF2B5EF4-FFF2-40B4-BE49-F238E27FC236}">
                <a16:creationId xmlns:a16="http://schemas.microsoft.com/office/drawing/2014/main" id="{19124DA2-216E-CBA8-E253-71EEF4E9207F}"/>
              </a:ext>
            </a:extLst>
          </p:cNvPr>
          <p:cNvSpPr/>
          <p:nvPr/>
        </p:nvSpPr>
        <p:spPr>
          <a:xfrm>
            <a:off x="5140749" y="1828800"/>
            <a:ext cx="1467316" cy="714375"/>
          </a:xfrm>
          <a:prstGeom prst="round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J-FT246135</a:t>
            </a:r>
          </a:p>
          <a:p>
            <a:pPr algn="ctr"/>
            <a:r>
              <a:rPr lang="en-US" sz="16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682 BCE</a:t>
            </a:r>
          </a:p>
          <a:p>
            <a:pPr algn="ctr"/>
            <a:endParaRPr lang="en-US" sz="16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Rounded Rectangle 5">
            <a:extLst>
              <a:ext uri="{FF2B5EF4-FFF2-40B4-BE49-F238E27FC236}">
                <a16:creationId xmlns:a16="http://schemas.microsoft.com/office/drawing/2014/main" id="{0E0B046C-5AF4-29B2-2EFF-FDB41BBA64C2}"/>
              </a:ext>
            </a:extLst>
          </p:cNvPr>
          <p:cNvSpPr/>
          <p:nvPr/>
        </p:nvSpPr>
        <p:spPr>
          <a:xfrm>
            <a:off x="2000971" y="3002756"/>
            <a:ext cx="1514787" cy="714375"/>
          </a:xfrm>
          <a:prstGeom prst="round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J-FT246365</a:t>
            </a:r>
            <a:br>
              <a:rPr lang="en-US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16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. 1174 CE</a:t>
            </a:r>
          </a:p>
        </p:txBody>
      </p:sp>
      <p:sp>
        <p:nvSpPr>
          <p:cNvPr id="7" name="Rounded Rectangle 6">
            <a:extLst>
              <a:ext uri="{FF2B5EF4-FFF2-40B4-BE49-F238E27FC236}">
                <a16:creationId xmlns:a16="http://schemas.microsoft.com/office/drawing/2014/main" id="{4C19FB97-114D-C365-F2CE-5676C4FC2AE2}"/>
              </a:ext>
            </a:extLst>
          </p:cNvPr>
          <p:cNvSpPr/>
          <p:nvPr/>
        </p:nvSpPr>
        <p:spPr>
          <a:xfrm>
            <a:off x="6120352" y="2986088"/>
            <a:ext cx="1532208" cy="731044"/>
          </a:xfrm>
          <a:prstGeom prst="round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J-Z11314</a:t>
            </a:r>
            <a:endParaRPr lang="en-US" sz="16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Rounded Rectangle 8">
            <a:extLst>
              <a:ext uri="{FF2B5EF4-FFF2-40B4-BE49-F238E27FC236}">
                <a16:creationId xmlns:a16="http://schemas.microsoft.com/office/drawing/2014/main" id="{83F049AD-0045-4F9B-F66A-E6320BB788AC}"/>
              </a:ext>
            </a:extLst>
          </p:cNvPr>
          <p:cNvSpPr/>
          <p:nvPr/>
        </p:nvSpPr>
        <p:spPr>
          <a:xfrm>
            <a:off x="8166111" y="3002756"/>
            <a:ext cx="1538722" cy="714375"/>
          </a:xfrm>
          <a:prstGeom prst="round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J-FT246135*</a:t>
            </a:r>
          </a:p>
        </p:txBody>
      </p:sp>
      <p:sp>
        <p:nvSpPr>
          <p:cNvPr id="3" name="Rounded Rectangle 2">
            <a:extLst>
              <a:ext uri="{FF2B5EF4-FFF2-40B4-BE49-F238E27FC236}">
                <a16:creationId xmlns:a16="http://schemas.microsoft.com/office/drawing/2014/main" id="{81E23C50-6B1E-575F-92B7-A9E1FC2F51C6}"/>
              </a:ext>
            </a:extLst>
          </p:cNvPr>
          <p:cNvSpPr/>
          <p:nvPr/>
        </p:nvSpPr>
        <p:spPr>
          <a:xfrm>
            <a:off x="4009279" y="2986088"/>
            <a:ext cx="1532208" cy="731044"/>
          </a:xfrm>
          <a:prstGeom prst="round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J-FT266880</a:t>
            </a:r>
            <a:r>
              <a:rPr lang="en-US" sz="16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pPr algn="ctr"/>
            <a:r>
              <a:rPr lang="en-US" sz="16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. 1096 CE</a:t>
            </a:r>
          </a:p>
        </p:txBody>
      </p:sp>
      <p:cxnSp>
        <p:nvCxnSpPr>
          <p:cNvPr id="5" name="Straight Arrow Connector 4">
            <a:extLst>
              <a:ext uri="{FF2B5EF4-FFF2-40B4-BE49-F238E27FC236}">
                <a16:creationId xmlns:a16="http://schemas.microsoft.com/office/drawing/2014/main" id="{D770AFC9-F120-332A-E0EE-C8505DFDD01D}"/>
              </a:ext>
            </a:extLst>
          </p:cNvPr>
          <p:cNvCxnSpPr>
            <a:cxnSpLocks/>
            <a:stCxn id="4" idx="2"/>
            <a:endCxn id="6" idx="0"/>
          </p:cNvCxnSpPr>
          <p:nvPr/>
        </p:nvCxnSpPr>
        <p:spPr>
          <a:xfrm flipH="1">
            <a:off x="2758365" y="2543175"/>
            <a:ext cx="3116042" cy="459581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BC59BDBF-192D-1367-514B-50B682486F3B}"/>
              </a:ext>
            </a:extLst>
          </p:cNvPr>
          <p:cNvCxnSpPr>
            <a:cxnSpLocks/>
            <a:stCxn id="4" idx="2"/>
            <a:endCxn id="3" idx="0"/>
          </p:cNvCxnSpPr>
          <p:nvPr/>
        </p:nvCxnSpPr>
        <p:spPr>
          <a:xfrm flipH="1">
            <a:off x="4775383" y="2543175"/>
            <a:ext cx="1099024" cy="442913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DC525061-004B-B25D-4DA4-0EB615567CA9}"/>
              </a:ext>
            </a:extLst>
          </p:cNvPr>
          <p:cNvCxnSpPr>
            <a:cxnSpLocks/>
            <a:stCxn id="4" idx="2"/>
            <a:endCxn id="7" idx="0"/>
          </p:cNvCxnSpPr>
          <p:nvPr/>
        </p:nvCxnSpPr>
        <p:spPr>
          <a:xfrm>
            <a:off x="5874407" y="2543175"/>
            <a:ext cx="1012049" cy="442913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9" name="Straight Arrow Connector 18">
            <a:extLst>
              <a:ext uri="{FF2B5EF4-FFF2-40B4-BE49-F238E27FC236}">
                <a16:creationId xmlns:a16="http://schemas.microsoft.com/office/drawing/2014/main" id="{5EF3A67C-66F0-3097-4987-98F5FED32738}"/>
              </a:ext>
            </a:extLst>
          </p:cNvPr>
          <p:cNvCxnSpPr>
            <a:cxnSpLocks/>
            <a:stCxn id="4" idx="2"/>
            <a:endCxn id="9" idx="0"/>
          </p:cNvCxnSpPr>
          <p:nvPr/>
        </p:nvCxnSpPr>
        <p:spPr>
          <a:xfrm>
            <a:off x="5874407" y="2543175"/>
            <a:ext cx="3061065" cy="459581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6" name="TextBox 25">
            <a:extLst>
              <a:ext uri="{FF2B5EF4-FFF2-40B4-BE49-F238E27FC236}">
                <a16:creationId xmlns:a16="http://schemas.microsoft.com/office/drawing/2014/main" id="{7D8572A2-6316-5715-87E6-827D350F2E3C}"/>
              </a:ext>
            </a:extLst>
          </p:cNvPr>
          <p:cNvSpPr txBox="1"/>
          <p:nvPr/>
        </p:nvSpPr>
        <p:spPr>
          <a:xfrm>
            <a:off x="209761" y="209270"/>
            <a:ext cx="838306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2b: Top-level branching for J-FT246135, CB-01’s secondary expansion node </a:t>
            </a:r>
          </a:p>
        </p:txBody>
      </p:sp>
    </p:spTree>
    <p:extLst>
      <p:ext uri="{BB962C8B-B14F-4D97-AF65-F5344CB8AC3E}">
        <p14:creationId xmlns:p14="http://schemas.microsoft.com/office/powerpoint/2010/main" val="39351204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01AEE6F-FAD5-2735-213C-4321AE549EE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0D35309D-2236-121D-2CAA-80D7947E1A43}"/>
              </a:ext>
            </a:extLst>
          </p:cNvPr>
          <p:cNvSpPr txBox="1"/>
          <p:nvPr/>
        </p:nvSpPr>
        <p:spPr>
          <a:xfrm>
            <a:off x="130629" y="118753"/>
            <a:ext cx="69901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3: CB-01 branching events by century, 1000 BCE to 1000 CE</a:t>
            </a:r>
          </a:p>
        </p:txBody>
      </p:sp>
      <p:pic>
        <p:nvPicPr>
          <p:cNvPr id="5" name="Picture 4" descr="A graph of a number of bars&#10;&#10;Description automatically generated">
            <a:extLst>
              <a:ext uri="{FF2B5EF4-FFF2-40B4-BE49-F238E27FC236}">
                <a16:creationId xmlns:a16="http://schemas.microsoft.com/office/drawing/2014/main" id="{DBF0CE2B-CBBE-0B13-B4EA-75F6227F502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87807" y="1111812"/>
            <a:ext cx="7772400" cy="463437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0754305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B8D33D1-505C-FB42-1FBD-BEFF5CDC8FD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BF1A5FA-AAB3-6CA4-A059-137896C7F230}"/>
              </a:ext>
            </a:extLst>
          </p:cNvPr>
          <p:cNvSpPr txBox="1"/>
          <p:nvPr/>
        </p:nvSpPr>
        <p:spPr>
          <a:xfrm>
            <a:off x="130629" y="118753"/>
            <a:ext cx="70866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4: Total CB-01 nodes extant by century, 1000 BCE to 1000 CE</a:t>
            </a:r>
          </a:p>
        </p:txBody>
      </p:sp>
      <p:pic>
        <p:nvPicPr>
          <p:cNvPr id="5" name="Picture 4" descr="A graph with a line going up&#10;&#10;Description automatically generated">
            <a:extLst>
              <a:ext uri="{FF2B5EF4-FFF2-40B4-BE49-F238E27FC236}">
                <a16:creationId xmlns:a16="http://schemas.microsoft.com/office/drawing/2014/main" id="{24E0C343-51DE-EF51-4166-686ECC1C710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33991" y="1488831"/>
            <a:ext cx="7772400" cy="463437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7262737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40C87D0-178F-FC7D-2D95-8CAAEB0E18D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924E35F8-A26C-4AC9-0662-1413EB51BC30}"/>
              </a:ext>
            </a:extLst>
          </p:cNvPr>
          <p:cNvSpPr txBox="1"/>
          <p:nvPr/>
        </p:nvSpPr>
        <p:spPr>
          <a:xfrm>
            <a:off x="130629" y="118753"/>
            <a:ext cx="42033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5: Top-level branching for CB-02 </a:t>
            </a:r>
          </a:p>
        </p:txBody>
      </p:sp>
      <p:pic>
        <p:nvPicPr>
          <p:cNvPr id="6" name="Picture 5" descr="A diagram of a number&#10;&#10;Description automatically generated">
            <a:extLst>
              <a:ext uri="{FF2B5EF4-FFF2-40B4-BE49-F238E27FC236}">
                <a16:creationId xmlns:a16="http://schemas.microsoft.com/office/drawing/2014/main" id="{AA077E8A-D16A-62BB-C35E-44515F57AF6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79444" y="1168400"/>
            <a:ext cx="10217426" cy="43055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7561047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70AA000-7E13-9DB6-41DF-97CDC323FF5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6C83FD32-0DD4-7EEE-CF48-073109D17C1E}"/>
              </a:ext>
            </a:extLst>
          </p:cNvPr>
          <p:cNvSpPr txBox="1"/>
          <p:nvPr/>
        </p:nvSpPr>
        <p:spPr>
          <a:xfrm>
            <a:off x="130629" y="118753"/>
            <a:ext cx="42033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6: Top-level branching for CB-03 </a:t>
            </a:r>
          </a:p>
        </p:txBody>
      </p:sp>
      <p:pic>
        <p:nvPicPr>
          <p:cNvPr id="3" name="Picture 2" descr="A diagram of a number&#10;&#10;Description automatically generated">
            <a:extLst>
              <a:ext uri="{FF2B5EF4-FFF2-40B4-BE49-F238E27FC236}">
                <a16:creationId xmlns:a16="http://schemas.microsoft.com/office/drawing/2014/main" id="{8E9CEAC2-7AFF-2538-A24C-938C85EBA8B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06945" y="1604341"/>
            <a:ext cx="10185124" cy="330040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2083171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FC88E17-E508-162D-E443-A8BA4BDED04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43306888-9203-44BC-401E-C1B680228939}"/>
              </a:ext>
            </a:extLst>
          </p:cNvPr>
          <p:cNvSpPr txBox="1"/>
          <p:nvPr/>
        </p:nvSpPr>
        <p:spPr>
          <a:xfrm>
            <a:off x="130629" y="118753"/>
            <a:ext cx="42033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7: Top-level branching for CB-04 </a:t>
            </a:r>
          </a:p>
        </p:txBody>
      </p:sp>
      <p:pic>
        <p:nvPicPr>
          <p:cNvPr id="9" name="Picture 8" descr="A diagram of a number&#10;&#10;Description automatically generated">
            <a:extLst>
              <a:ext uri="{FF2B5EF4-FFF2-40B4-BE49-F238E27FC236}">
                <a16:creationId xmlns:a16="http://schemas.microsoft.com/office/drawing/2014/main" id="{10A18D87-F1F5-D49B-7CC6-1C7DBC2D0FD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59512" y="1853167"/>
            <a:ext cx="10628905" cy="333249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0405118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34DE897-029B-07C5-730A-AEADDE888AF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EA72D641-6F3B-D53D-BAE8-5F03C32FF836}"/>
              </a:ext>
            </a:extLst>
          </p:cNvPr>
          <p:cNvSpPr txBox="1"/>
          <p:nvPr/>
        </p:nvSpPr>
        <p:spPr>
          <a:xfrm>
            <a:off x="130629" y="118753"/>
            <a:ext cx="64905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8: Top-level branching for CB-05, with nearest outgroup </a:t>
            </a:r>
          </a:p>
        </p:txBody>
      </p:sp>
      <p:pic>
        <p:nvPicPr>
          <p:cNvPr id="5" name="Picture 4" descr="A diagram of a number&#10;&#10;Description automatically generated">
            <a:extLst>
              <a:ext uri="{FF2B5EF4-FFF2-40B4-BE49-F238E27FC236}">
                <a16:creationId xmlns:a16="http://schemas.microsoft.com/office/drawing/2014/main" id="{93AFFA4E-E0AB-4126-A665-60F4265EC97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08099" y="1504950"/>
            <a:ext cx="8819383" cy="354412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35116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5</TotalTime>
  <Words>166</Words>
  <Application>Microsoft Macintosh PowerPoint</Application>
  <PresentationFormat>Widescreen</PresentationFormat>
  <Paragraphs>25</Paragraphs>
  <Slides>13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3</vt:i4>
      </vt:variant>
    </vt:vector>
  </HeadingPairs>
  <TitlesOfParts>
    <vt:vector size="18" baseType="lpstr">
      <vt:lpstr>Aptos</vt:lpstr>
      <vt:lpstr>Aptos Display</vt:lpstr>
      <vt:lpstr>Arial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jl5721</dc:creator>
  <cp:lastModifiedBy>Lipson, Joshua (OMH)</cp:lastModifiedBy>
  <cp:revision>21</cp:revision>
  <dcterms:created xsi:type="dcterms:W3CDTF">2025-04-07T16:47:02Z</dcterms:created>
  <dcterms:modified xsi:type="dcterms:W3CDTF">2025-12-08T16:23:30Z</dcterms:modified>
</cp:coreProperties>
</file>